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3" autoAdjust="0"/>
    <p:restoredTop sz="94660"/>
  </p:normalViewPr>
  <p:slideViewPr>
    <p:cSldViewPr snapToGrid="0" showGuides="1">
      <p:cViewPr varScale="1">
        <p:scale>
          <a:sx n="43" d="100"/>
          <a:sy n="43" d="100"/>
        </p:scale>
        <p:origin x="64" y="2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CF8398-6241-4308-8373-7DC7477C486A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CD1A3-F3DF-4636-BCEF-38FE50562F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5740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D44770-FE23-431D-B2E2-DDE2B2E868A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1448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DA5E95-276F-41E6-B355-F71120253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58905D6-F05F-448F-B3CB-D92F5E2CDB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B74AAD-0E1A-4C65-8F9E-709B9ECB4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2FA78C-BA0B-4D10-9493-1121BA717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4AB5D1-F246-4D36-BA60-44380B574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2099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197D1A-1C51-4A4B-AF21-FF9B690F0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1FDD8C9-D1E8-44DA-A80B-94ABA5CFA0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4463DE-3784-44E3-BEAF-820EEC8A8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81FDA1-A31F-4ADA-AE7B-C068D4262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61A960-41BF-413F-B5EF-C1C5033CC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804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CC33957-7EA7-41BF-846E-23B1517631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D967F3-26DB-46B4-BDC0-6554EC82C3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AF5F1B-CBA0-4F94-8D6E-BFDAB5FE2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A50ECD-7ED9-4826-AECF-73341E1B7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EBEA35-CF80-44EF-977A-D9F6FA118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5650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C0BEDE-BD89-4DD3-AF78-F3D2B1330B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1DECD2-88BC-4E97-9FD6-A137120E15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C4EDAB-6B2F-4C29-AE7C-B59F1A061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03307F-3B4C-4C8A-9D9E-217B21BBD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589694-ABBD-46E2-8F92-08C535B5C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3126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9039DB-9DF9-46C6-AEBC-6B1F72FCDC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5042D-29A3-4CAC-9580-565E4A034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B103BA-764F-4817-BC95-00E66AB11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0BB63D-FB42-447D-A120-099CB6225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55CC85-D5B6-4606-BFD6-F298E58E0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171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407E67-DE38-4383-9DBB-5E99E731AF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63F60A-7F68-4E16-8485-140FC38928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7C12C14-DB98-486D-A69E-4C32837D5A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DF2A6A-63F9-4F4F-900D-527C59741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6C5B999-2849-4498-A4B1-84068CC79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51D070-3CB3-4ED3-B740-C2298EAAB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4481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C312AC-3CA9-478B-9104-95D76320F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165513-9457-498C-83A2-E4B9082D9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5388243-5DE6-4893-985E-A9E0DBA4B7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57AFD1A-2C85-47A1-AE55-77C1AE0D38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DA21E0F-5221-49F1-B826-53642A8224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B89D72E-2F67-49FC-8034-0BA380883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7D38E7C-B2AB-4379-BA8F-DCA512E6A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7018F18-24EC-4CB2-8F39-B281F1A1F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42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AA72EF-ACF6-4B84-8111-0B0F8C886F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C39BB4F-5B2E-4C10-A8AB-A7FF590F6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692D45F-9981-4CE2-BF90-20E1CF1C8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5B2F847-E5C0-4E12-AB0A-68FBD4A8C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887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FD00D20-2A07-4ED1-BBD6-6C6AC5FEA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194EADC-E4C8-487D-9AE1-91EC7DF2F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FDC454-D6C5-471A-AF67-20EDF2B10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5302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9295EB-77A0-40F7-8A78-3D5649BF7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F09CAA-A702-4E4D-87DD-FECB3F3D9B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61DBEC-720E-408D-A68D-FD6C74A954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F75138-8A10-445E-92B5-EE7DA154B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38BB822-893E-44F9-B2A6-883FDD4A3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4A1623-1FE2-44C4-98B9-F9215F609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6990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FDA2CB-FB3D-4D7D-98F5-C7A08E3F3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6F5DB79-B16D-43CA-8433-F50BD1DB50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2DD0E59-E477-4698-BC02-8F6F0E7F6F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CBC461-C359-440B-BBA3-26C8A6FDA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402E5B-87C7-44BF-B362-DA099473C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9F0603-C9F6-48AF-9B3E-A5D9CC19F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5230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D7E81AE-4CB9-4791-9E78-8AD9DB023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C3C286-643A-46C3-B7BD-0C7E1C5FBA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EFEEE8-6F6B-4C33-801C-AFFEC1454E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2AF8F-2FFE-41F7-AC16-BA98707FD1AF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CD1950-82EA-4E60-A23B-3D343EE9EB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EBB4B6-DC0D-49B3-AC9B-23E58AA7A8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1C233-377A-43D4-A027-3C5260400E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946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1FB32F26-5BEA-4D72-A6F7-A4095702311F}"/>
              </a:ext>
            </a:extLst>
          </p:cNvPr>
          <p:cNvGrpSpPr/>
          <p:nvPr/>
        </p:nvGrpSpPr>
        <p:grpSpPr>
          <a:xfrm>
            <a:off x="0" y="142435"/>
            <a:ext cx="9960421" cy="6260580"/>
            <a:chOff x="0" y="91636"/>
            <a:chExt cx="9960421" cy="6260580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E761425C-3EFE-4720-A086-FFFB62711C49}"/>
                </a:ext>
              </a:extLst>
            </p:cNvPr>
            <p:cNvSpPr>
              <a:spLocks/>
            </p:cNvSpPr>
            <p:nvPr/>
          </p:nvSpPr>
          <p:spPr>
            <a:xfrm>
              <a:off x="3369939" y="91636"/>
              <a:ext cx="3108322" cy="159507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arched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rticles</a:t>
              </a:r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N=1325)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PubMed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N=260)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EMBASE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82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Cochrane database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60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CNKI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68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CBM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101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VIP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2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WF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332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8BC3DDD2-9042-4040-91FB-1D3EE45CE63A}"/>
                </a:ext>
              </a:extLst>
            </p:cNvPr>
            <p:cNvSpPr>
              <a:spLocks/>
            </p:cNvSpPr>
            <p:nvPr/>
          </p:nvSpPr>
          <p:spPr>
            <a:xfrm>
              <a:off x="3369939" y="2135364"/>
              <a:ext cx="3108322" cy="5601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Titles and abstracts screening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=1129</a:t>
              </a:r>
              <a:endPara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A4A5B2CB-7E4E-4ACE-BEF6-6F0DB720C4D6}"/>
                </a:ext>
              </a:extLst>
            </p:cNvPr>
            <p:cNvSpPr>
              <a:spLocks/>
            </p:cNvSpPr>
            <p:nvPr/>
          </p:nvSpPr>
          <p:spPr>
            <a:xfrm>
              <a:off x="3369939" y="3877857"/>
              <a:ext cx="3108322" cy="5601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</a:t>
              </a:r>
              <a:r>
                <a: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ull text </a:t>
              </a:r>
              <a:r>
                <a:rPr kumimoji="0" lang="en-US" altLang="zh-CN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creening</a:t>
              </a:r>
            </a:p>
            <a:p>
              <a:pPr algn="ctr">
                <a:defRPr/>
              </a:pPr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=91</a:t>
              </a:r>
              <a:endPara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BB1B6CFD-BD93-436C-8CED-215B574C60C6}"/>
                </a:ext>
              </a:extLst>
            </p:cNvPr>
            <p:cNvSpPr/>
            <p:nvPr/>
          </p:nvSpPr>
          <p:spPr>
            <a:xfrm>
              <a:off x="6763038" y="2350622"/>
              <a:ext cx="3197383" cy="2076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xcluded N=1038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Irrelevant</a:t>
              </a:r>
              <a:r>
                <a:rPr lang="zh-CN" altLang="en-US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446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)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eviews (N=280)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Case reports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132)</a:t>
              </a:r>
              <a:endPara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Protocols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50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) </a:t>
              </a:r>
            </a:p>
            <a:p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Only abstract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(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6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)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</a:t>
              </a:r>
            </a:p>
            <a:p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Editorials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(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=5)</a:t>
              </a:r>
            </a:p>
            <a:p>
              <a:pPr lvl="0"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Retracted articles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1)</a:t>
              </a:r>
              <a:endPara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 lvl="0"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Not in English (English database)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45)</a:t>
              </a:r>
            </a:p>
            <a:p>
              <a:pPr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Not in Chinese (Chinese database)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42)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Animals experiments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1)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D57E2BF8-9C3E-4659-AF13-CEB6A2F7FF46}"/>
                </a:ext>
              </a:extLst>
            </p:cNvPr>
            <p:cNvSpPr/>
            <p:nvPr/>
          </p:nvSpPr>
          <p:spPr>
            <a:xfrm>
              <a:off x="6786810" y="4638140"/>
              <a:ext cx="3172881" cy="68447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Excluded </a:t>
              </a:r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=71</a:t>
              </a:r>
              <a:endPara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>
                <a:defRPr/>
              </a:pP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The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xperimental pain model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(N=26)</a:t>
              </a:r>
            </a:p>
            <a:p>
              <a:pPr>
                <a:defRPr/>
              </a:pP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Other no migraine diseases studies (N=45)</a:t>
              </a: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268B35B0-71AF-45E1-984C-2AB194B08DE3}"/>
                </a:ext>
              </a:extLst>
            </p:cNvPr>
            <p:cNvSpPr/>
            <p:nvPr/>
          </p:nvSpPr>
          <p:spPr>
            <a:xfrm>
              <a:off x="6763039" y="1657162"/>
              <a:ext cx="2599498" cy="44769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uplicate articles N=196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2E61AD46-9957-46C9-BA6F-80D103BC8225}"/>
                </a:ext>
              </a:extLst>
            </p:cNvPr>
            <p:cNvCxnSpPr>
              <a:cxnSpLocks/>
              <a:stCxn id="5" idx="2"/>
              <a:endCxn id="6" idx="0"/>
            </p:cNvCxnSpPr>
            <p:nvPr/>
          </p:nvCxnSpPr>
          <p:spPr>
            <a:xfrm>
              <a:off x="4924100" y="1686710"/>
              <a:ext cx="0" cy="44865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5F2BB250-584A-4DCA-8823-76E68B8FF97E}"/>
                </a:ext>
              </a:extLst>
            </p:cNvPr>
            <p:cNvCxnSpPr>
              <a:cxnSpLocks/>
              <a:stCxn id="6" idx="2"/>
              <a:endCxn id="7" idx="0"/>
            </p:cNvCxnSpPr>
            <p:nvPr/>
          </p:nvCxnSpPr>
          <p:spPr>
            <a:xfrm>
              <a:off x="4924100" y="2695480"/>
              <a:ext cx="0" cy="118237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8436EF70-F5DB-4EB2-9090-1132482B5B9A}"/>
                </a:ext>
              </a:extLst>
            </p:cNvPr>
            <p:cNvCxnSpPr>
              <a:cxnSpLocks/>
              <a:stCxn id="7" idx="2"/>
              <a:endCxn id="34" idx="0"/>
            </p:cNvCxnSpPr>
            <p:nvPr/>
          </p:nvCxnSpPr>
          <p:spPr>
            <a:xfrm>
              <a:off x="4924100" y="4437973"/>
              <a:ext cx="14382" cy="135412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4130FC53-7310-4BF2-A9C1-38F3B8109B59}"/>
                </a:ext>
              </a:extLst>
            </p:cNvPr>
            <p:cNvCxnSpPr>
              <a:cxnSpLocks/>
              <a:endCxn id="10" idx="1"/>
            </p:cNvCxnSpPr>
            <p:nvPr/>
          </p:nvCxnSpPr>
          <p:spPr>
            <a:xfrm>
              <a:off x="4924100" y="1881008"/>
              <a:ext cx="183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接箭头连接符 15">
              <a:extLst>
                <a:ext uri="{FF2B5EF4-FFF2-40B4-BE49-F238E27FC236}">
                  <a16:creationId xmlns:a16="http://schemas.microsoft.com/office/drawing/2014/main" id="{A384253C-2FD5-4BAE-B01E-BCC0F2B25FD5}"/>
                </a:ext>
              </a:extLst>
            </p:cNvPr>
            <p:cNvCxnSpPr>
              <a:cxnSpLocks/>
            </p:cNvCxnSpPr>
            <p:nvPr/>
          </p:nvCxnSpPr>
          <p:spPr>
            <a:xfrm>
              <a:off x="4924100" y="3388854"/>
              <a:ext cx="183893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C014C56-664E-4EF3-9C87-82376C09EDFE}"/>
                </a:ext>
              </a:extLst>
            </p:cNvPr>
            <p:cNvSpPr txBox="1"/>
            <p:nvPr/>
          </p:nvSpPr>
          <p:spPr>
            <a:xfrm>
              <a:off x="0" y="474281"/>
              <a:ext cx="290524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</a:t>
              </a:r>
              <a:r>
                <a:rPr lang="zh-CN" alt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1.</a:t>
              </a: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C239CD98-2B20-462A-92B8-D7DB1F754C67}"/>
                </a:ext>
              </a:extLst>
            </p:cNvPr>
            <p:cNvSpPr/>
            <p:nvPr/>
          </p:nvSpPr>
          <p:spPr>
            <a:xfrm>
              <a:off x="0" y="843613"/>
              <a:ext cx="3369939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>
                <a:defRPr/>
              </a:pPr>
              <a:r>
                <a:rPr lang="en-US" altLang="zh-CN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e f</a:t>
              </a:r>
              <a:r>
                <a:rPr lang="zh-CN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 diagram </a:t>
              </a:r>
              <a:r>
                <a:rPr lang="en-US" altLang="zh-CN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zh-CN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terature search and screening process</a:t>
              </a:r>
              <a:endParaRPr lang="zh-CN" altLang="en-US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箭头连接符 18">
              <a:extLst>
                <a:ext uri="{FF2B5EF4-FFF2-40B4-BE49-F238E27FC236}">
                  <a16:creationId xmlns:a16="http://schemas.microsoft.com/office/drawing/2014/main" id="{B9CE4EF7-C323-44E7-B570-036942A2D67C}"/>
                </a:ext>
              </a:extLst>
            </p:cNvPr>
            <p:cNvCxnSpPr>
              <a:cxnSpLocks/>
              <a:stCxn id="20" idx="3"/>
              <a:endCxn id="9" idx="1"/>
            </p:cNvCxnSpPr>
            <p:nvPr/>
          </p:nvCxnSpPr>
          <p:spPr>
            <a:xfrm flipV="1">
              <a:off x="3369939" y="4980379"/>
              <a:ext cx="3416871" cy="7411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F91E2B23-FD3F-40B6-B7BD-311979E29A18}"/>
                </a:ext>
              </a:extLst>
            </p:cNvPr>
            <p:cNvSpPr/>
            <p:nvPr/>
          </p:nvSpPr>
          <p:spPr>
            <a:xfrm>
              <a:off x="564407" y="4652962"/>
              <a:ext cx="2805532" cy="66965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Retrospective Searching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Included N=8</a:t>
              </a: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DB6EDD90-99D2-47FD-A48C-6E97BB07F65A}"/>
                </a:ext>
              </a:extLst>
            </p:cNvPr>
            <p:cNvSpPr>
              <a:spLocks/>
            </p:cNvSpPr>
            <p:nvPr/>
          </p:nvSpPr>
          <p:spPr>
            <a:xfrm>
              <a:off x="1738082" y="5792100"/>
              <a:ext cx="6400799" cy="56011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he neuroimaging studies of </a:t>
              </a:r>
              <a:r>
                <a:rPr kumimoji="0" lang="en-US" altLang="zh-CN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Migraine</a:t>
              </a:r>
            </a:p>
            <a:p>
              <a:pPr algn="ctr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=28</a:t>
              </a:r>
              <a:endPara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73922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22</Words>
  <Application>Microsoft Office PowerPoint</Application>
  <PresentationFormat>宽屏</PresentationFormat>
  <Paragraphs>3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dai .</dc:creator>
  <cp:lastModifiedBy>Madai .</cp:lastModifiedBy>
  <cp:revision>2</cp:revision>
  <dcterms:created xsi:type="dcterms:W3CDTF">2021-10-14T22:35:00Z</dcterms:created>
  <dcterms:modified xsi:type="dcterms:W3CDTF">2021-10-14T22:47:10Z</dcterms:modified>
</cp:coreProperties>
</file>